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6762EBA-6B5B-4546-A7D6-85F9A25D88DD}" v="2" dt="2025-03-26T08:19:51.87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121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平良 淳誠@沖縄高専" userId="259848bc-ac68-4361-9437-19c9a1a50856" providerId="ADAL" clId="{86762EBA-6B5B-4546-A7D6-85F9A25D88DD}"/>
    <pc:docChg chg="modSld">
      <pc:chgData name="平良 淳誠@沖縄高専" userId="259848bc-ac68-4361-9437-19c9a1a50856" providerId="ADAL" clId="{86762EBA-6B5B-4546-A7D6-85F9A25D88DD}" dt="2025-03-26T08:20:05.367" v="3" actId="403"/>
      <pc:docMkLst>
        <pc:docMk/>
      </pc:docMkLst>
      <pc:sldChg chg="modSp mod">
        <pc:chgData name="平良 淳誠@沖縄高専" userId="259848bc-ac68-4361-9437-19c9a1a50856" providerId="ADAL" clId="{86762EBA-6B5B-4546-A7D6-85F9A25D88DD}" dt="2025-03-26T08:20:05.367" v="3" actId="403"/>
        <pc:sldMkLst>
          <pc:docMk/>
          <pc:sldMk cId="1682723972" sldId="256"/>
        </pc:sldMkLst>
        <pc:graphicFrameChg chg="mod modGraphic">
          <ac:chgData name="平良 淳誠@沖縄高専" userId="259848bc-ac68-4361-9437-19c9a1a50856" providerId="ADAL" clId="{86762EBA-6B5B-4546-A7D6-85F9A25D88DD}" dt="2025-03-26T08:20:05.367" v="3" actId="403"/>
          <ac:graphicFrameMkLst>
            <pc:docMk/>
            <pc:sldMk cId="1682723972" sldId="256"/>
            <ac:graphicFrameMk id="9" creationId="{EED22C0D-12F9-7550-314A-3281FE7A2F3B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9AAF1E-2330-3681-AD15-1DD1657532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5CD2E26-A88B-CC13-2CA6-3894AF9D8A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1C0A44-3C75-4323-EDFE-F2BD077C6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41F5D3-2DED-41A5-F62C-49AC1C9F2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BDFF64-3801-89FF-2BAD-FA2A2531F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000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79650B-7621-B2D0-7815-FF88788B8F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A617DCE-CBDF-56BC-6AE1-7CD12781B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8F16C2-F027-3163-02A7-BB7B21B51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49700B-FE68-B741-E4B3-C431FFAE6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07AAC1-4A1F-7619-C8E5-FB344D46D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111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ECE2D45-4002-D99E-FA4B-229EDD3D18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9D544A-7E76-9E92-179E-212F3BEE8B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BCB392-4C32-1923-0A50-3DA4819BE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16D902-8788-EB6C-4645-2F97B5F1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92F593-9649-3E79-5B07-DEB6FDE7D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01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D566F9-E7A1-70FC-45D8-2911D4F61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D4B149-30ED-A168-F7FE-2EF05E8402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3BD8AE-A08B-C2E0-84A0-DD81AC44E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DC22A0-775B-D658-D5ED-ED763A127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09DC52-0F8A-0175-A6EF-86DF3B235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963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6B8CC9-5ECE-85D6-3340-E2F8B9599B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558112-878A-71A1-F015-D59D293235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8ADD35-3A66-E06B-2445-3F2D34A66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41C091-4D82-C88D-2B6A-C04467E41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0A260C-799D-934D-89CC-99029780A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858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AB9223-80E5-FD27-13C7-6366D7D367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0A4CD84-C024-3E4C-8195-971887A695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FCC282D-2886-7E16-64BB-E3AE381CBA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40A5D8-956B-6AFB-FA6E-CCE509346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B716C6-4E1C-7BAA-8D1A-7C5F4928A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88B8852-F1A4-2F23-0AED-BD19DA3C7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5118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105A31-DC76-B138-1119-B9CCB010A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F5F13F2-CEFB-E083-1DCB-3E00A6DE41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A9B02BB-A717-3892-F718-D291A545F3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AC44FE0-D58F-89D9-895E-47FDA035B7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6A8069D-6FE8-B44B-07F4-F180BC792D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0DBF35B-0CE5-4C32-F7F7-748090672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A735E81-C111-B133-9939-1A49F8A27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47F30F0-D3DB-6DDC-9F0A-BF3BC2A6E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091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E0944E-D67B-592F-4D52-DA3CCF7A02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484D339-ACB5-4722-6C03-D0109D5C6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91D4FFA-6A83-4A72-9BF3-04902DFAF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6658BF0-C6EE-323F-89C5-9611B7644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6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AF44670-1704-F1DF-16E7-E2C86B8B5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50C4A9A-038A-9FBC-74EE-F71908A34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97E4509-9623-B597-6C98-0779341BE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698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87046C-16FF-B16A-0629-6D79123BD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FAC9BF-B529-3D21-577E-83680CB55F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819409E-C073-D9BA-4743-811401D3F8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FB6977-5423-E990-F892-60FD19C72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2AF9590-0337-9DEF-874C-7617EA3C3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DD5EAB4-4C38-EA82-9428-4AB3E854F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2887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2B632D-498D-50AA-B7BB-FBD1361C1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3EE3CA2-0179-9719-4481-3DE8AA5BF6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0B9208-542A-42DD-8A43-512F246FB9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18059F-C355-FA6B-46AC-119CEDD9E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A236EC2-49C1-DC80-414F-4226AC207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2B41B1-0542-F9F1-810D-8D5B185FD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001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75DA55E-B1C9-3CBB-3771-9C379F1B4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1DD99A-FCE4-1B86-98E4-5401CB6106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0E741A-F469-11F8-FBAC-52BAFCB81B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760F506-BFB2-4796-9586-2804335662DA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3C16A9-3632-FC6B-287B-41F137458D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8C8B8D-22D0-EEF5-A315-2067DF7374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0C8219-FBF9-4408-8838-106ECDB8E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582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EED22C0D-12F9-7550-314A-3281FE7A2F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6893688"/>
              </p:ext>
            </p:extLst>
          </p:nvPr>
        </p:nvGraphicFramePr>
        <p:xfrm>
          <a:off x="1650093" y="881742"/>
          <a:ext cx="9050564" cy="4539341"/>
        </p:xfrm>
        <a:graphic>
          <a:graphicData uri="http://schemas.openxmlformats.org/drawingml/2006/table">
            <a:tbl>
              <a:tblPr/>
              <a:tblGrid>
                <a:gridCol w="1128708">
                  <a:extLst>
                    <a:ext uri="{9D8B030D-6E8A-4147-A177-3AD203B41FA5}">
                      <a16:colId xmlns:a16="http://schemas.microsoft.com/office/drawing/2014/main" val="3169693373"/>
                    </a:ext>
                  </a:extLst>
                </a:gridCol>
                <a:gridCol w="595707">
                  <a:extLst>
                    <a:ext uri="{9D8B030D-6E8A-4147-A177-3AD203B41FA5}">
                      <a16:colId xmlns:a16="http://schemas.microsoft.com/office/drawing/2014/main" val="4188134744"/>
                    </a:ext>
                  </a:extLst>
                </a:gridCol>
                <a:gridCol w="1149610">
                  <a:extLst>
                    <a:ext uri="{9D8B030D-6E8A-4147-A177-3AD203B41FA5}">
                      <a16:colId xmlns:a16="http://schemas.microsoft.com/office/drawing/2014/main" val="1322151129"/>
                    </a:ext>
                  </a:extLst>
                </a:gridCol>
                <a:gridCol w="1107805">
                  <a:extLst>
                    <a:ext uri="{9D8B030D-6E8A-4147-A177-3AD203B41FA5}">
                      <a16:colId xmlns:a16="http://schemas.microsoft.com/office/drawing/2014/main" val="2330586426"/>
                    </a:ext>
                  </a:extLst>
                </a:gridCol>
                <a:gridCol w="982394">
                  <a:extLst>
                    <a:ext uri="{9D8B030D-6E8A-4147-A177-3AD203B41FA5}">
                      <a16:colId xmlns:a16="http://schemas.microsoft.com/office/drawing/2014/main" val="349980718"/>
                    </a:ext>
                  </a:extLst>
                </a:gridCol>
                <a:gridCol w="501648">
                  <a:extLst>
                    <a:ext uri="{9D8B030D-6E8A-4147-A177-3AD203B41FA5}">
                      <a16:colId xmlns:a16="http://schemas.microsoft.com/office/drawing/2014/main" val="1398683586"/>
                    </a:ext>
                  </a:extLst>
                </a:gridCol>
                <a:gridCol w="919688">
                  <a:extLst>
                    <a:ext uri="{9D8B030D-6E8A-4147-A177-3AD203B41FA5}">
                      <a16:colId xmlns:a16="http://schemas.microsoft.com/office/drawing/2014/main" val="2295782027"/>
                    </a:ext>
                  </a:extLst>
                </a:gridCol>
                <a:gridCol w="1027681">
                  <a:extLst>
                    <a:ext uri="{9D8B030D-6E8A-4147-A177-3AD203B41FA5}">
                      <a16:colId xmlns:a16="http://schemas.microsoft.com/office/drawing/2014/main" val="3160279698"/>
                    </a:ext>
                  </a:extLst>
                </a:gridCol>
                <a:gridCol w="992845">
                  <a:extLst>
                    <a:ext uri="{9D8B030D-6E8A-4147-A177-3AD203B41FA5}">
                      <a16:colId xmlns:a16="http://schemas.microsoft.com/office/drawing/2014/main" val="4047199201"/>
                    </a:ext>
                  </a:extLst>
                </a:gridCol>
                <a:gridCol w="644478">
                  <a:extLst>
                    <a:ext uri="{9D8B030D-6E8A-4147-A177-3AD203B41FA5}">
                      <a16:colId xmlns:a16="http://schemas.microsoft.com/office/drawing/2014/main" val="3757692499"/>
                    </a:ext>
                  </a:extLst>
                </a:gridCol>
              </a:tblGrid>
              <a:tr h="40019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ble 1 The results of this preliminary experiment for anti-HBV activity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=3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9621501"/>
                  </a:ext>
                </a:extLst>
              </a:tr>
              <a:tr h="354458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est sample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HBV pgRNA (copy/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明朝" panose="02020400000000000000" pitchFamily="18" charset="-128"/>
                        </a:rPr>
                        <a:t>m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g RNA) 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F0C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 Total RN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CE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6835955"/>
                  </a:ext>
                </a:extLst>
              </a:tr>
              <a:tr h="343023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D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 of cont.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D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D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% of cont.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D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4814787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ontrol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   (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ゴシック" panose="020B0400000000000000" pitchFamily="50" charset="-128"/>
                        </a:rPr>
                        <a:t>m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279639.1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71938.7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1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1.7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2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3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5425427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amivudin (LV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89825.3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3401.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0.8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0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7.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7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5.8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.4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513744"/>
                  </a:ext>
                </a:extLst>
              </a:tr>
              <a:tr h="514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Fucoxanthin (Fx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*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91928.2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11139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2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.9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.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0.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5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5417269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ell death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672176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ell death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6906348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teryxin (Ptx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672168.6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893819.4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2.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.7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8.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6.7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8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5520467"/>
                  </a:ext>
                </a:extLst>
              </a:tr>
              <a:tr h="34302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0</a:t>
                      </a:r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304903.9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49551.0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4.8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.1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4.6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2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2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7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3974466"/>
                  </a:ext>
                </a:extLst>
              </a:tr>
              <a:tr h="35445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803215.0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1679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0.0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5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2.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.8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7.9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.6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1768686"/>
                  </a:ext>
                </a:extLst>
              </a:tr>
              <a:tr h="51453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*These concentrations for the evaluation of anti-HBVactivity.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53113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2723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40</Words>
  <Application>Microsoft Office PowerPoint</Application>
  <PresentationFormat>ワイド画面</PresentationFormat>
  <Paragraphs>8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Symbo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平良 淳誠@沖縄高専</dc:creator>
  <cp:lastModifiedBy>平良 淳誠@沖縄高専</cp:lastModifiedBy>
  <cp:revision>1</cp:revision>
  <dcterms:created xsi:type="dcterms:W3CDTF">2025-03-19T22:34:32Z</dcterms:created>
  <dcterms:modified xsi:type="dcterms:W3CDTF">2025-03-26T08:20:14Z</dcterms:modified>
</cp:coreProperties>
</file>